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notesMasterIdLst>
    <p:notesMasterId r:id="rId6"/>
  </p:notesMasterIdLst>
  <p:sldIdLst>
    <p:sldId id="263" r:id="rId5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A0A4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ED025C5-231F-4688-81F7-35915B831BE5}" v="25" dt="2023-03-02T01:00:25.5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389" autoAdjust="0"/>
    <p:restoredTop sz="96181" autoAdjust="0"/>
  </p:normalViewPr>
  <p:slideViewPr>
    <p:cSldViewPr snapToGrid="0">
      <p:cViewPr varScale="1">
        <p:scale>
          <a:sx n="93" d="100"/>
          <a:sy n="93" d="100"/>
        </p:scale>
        <p:origin x="14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hIPqPCR710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hIPqPCR7102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L$24</c:f>
              <c:strCache>
                <c:ptCount val="1"/>
                <c:pt idx="0">
                  <c:v>H3k36me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K$25:$K$26</c:f>
              <c:strCache>
                <c:ptCount val="2"/>
                <c:pt idx="0">
                  <c:v>Amelxpr Pitx2</c:v>
                </c:pt>
                <c:pt idx="1">
                  <c:v>Amelxpr cntr</c:v>
                </c:pt>
              </c:strCache>
            </c:strRef>
          </c:cat>
          <c:val>
            <c:numRef>
              <c:f>Sheet2!$L$25:$L$26</c:f>
              <c:numCache>
                <c:formatCode>General</c:formatCode>
                <c:ptCount val="2"/>
                <c:pt idx="0">
                  <c:v>2.8531761237807398</c:v>
                </c:pt>
                <c:pt idx="1">
                  <c:v>1.2370175838856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1C-2F46-9179-BA32CA0F2033}"/>
            </c:ext>
          </c:extLst>
        </c:ser>
        <c:ser>
          <c:idx val="1"/>
          <c:order val="1"/>
          <c:tx>
            <c:strRef>
              <c:f>Sheet2!$M$24</c:f>
              <c:strCache>
                <c:ptCount val="1"/>
                <c:pt idx="0">
                  <c:v>Ig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K$25:$K$26</c:f>
              <c:strCache>
                <c:ptCount val="2"/>
                <c:pt idx="0">
                  <c:v>Amelxpr Pitx2</c:v>
                </c:pt>
                <c:pt idx="1">
                  <c:v>Amelxpr cntr</c:v>
                </c:pt>
              </c:strCache>
            </c:strRef>
          </c:cat>
          <c:val>
            <c:numRef>
              <c:f>Sheet2!$M$25:$M$26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61C-2F46-9179-BA32CA0F20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736600"/>
        <c:axId val="429743488"/>
      </c:barChart>
      <c:catAx>
        <c:axId val="429736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429743488"/>
        <c:crosses val="autoZero"/>
        <c:auto val="1"/>
        <c:lblAlgn val="ctr"/>
        <c:lblOffset val="100"/>
        <c:noMultiLvlLbl val="0"/>
      </c:catAx>
      <c:valAx>
        <c:axId val="429743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4297366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490116108664378"/>
          <c:y val="0.84843514164182254"/>
          <c:w val="0.72236217244464196"/>
          <c:h val="0.108913508435755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L$27</c:f>
              <c:strCache>
                <c:ptCount val="1"/>
                <c:pt idx="0">
                  <c:v>H3k36me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2!$K$28:$K$29</c:f>
              <c:strCache>
                <c:ptCount val="2"/>
                <c:pt idx="0">
                  <c:v>Sox2pr Pitx2</c:v>
                </c:pt>
                <c:pt idx="1">
                  <c:v>Sox2pr cntr</c:v>
                </c:pt>
              </c:strCache>
            </c:strRef>
          </c:cat>
          <c:val>
            <c:numRef>
              <c:f>Sheet2!$L$28:$L$29</c:f>
              <c:numCache>
                <c:formatCode>General</c:formatCode>
                <c:ptCount val="2"/>
                <c:pt idx="0">
                  <c:v>3.3869812494501041</c:v>
                </c:pt>
                <c:pt idx="1">
                  <c:v>1.47426921729109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23-5540-B186-B57FCD4FF7A2}"/>
            </c:ext>
          </c:extLst>
        </c:ser>
        <c:ser>
          <c:idx val="1"/>
          <c:order val="1"/>
          <c:tx>
            <c:strRef>
              <c:f>Sheet2!$M$27</c:f>
              <c:strCache>
                <c:ptCount val="1"/>
                <c:pt idx="0">
                  <c:v>IgG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K$28:$K$29</c:f>
              <c:strCache>
                <c:ptCount val="2"/>
                <c:pt idx="0">
                  <c:v>Sox2pr Pitx2</c:v>
                </c:pt>
                <c:pt idx="1">
                  <c:v>Sox2pr cntr</c:v>
                </c:pt>
              </c:strCache>
            </c:strRef>
          </c:cat>
          <c:val>
            <c:numRef>
              <c:f>Sheet2!$M$28:$M$29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F23-5540-B186-B57FCD4FF7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9733976"/>
        <c:axId val="429738240"/>
      </c:barChart>
      <c:catAx>
        <c:axId val="429733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429738240"/>
        <c:crosses val="autoZero"/>
        <c:auto val="1"/>
        <c:lblAlgn val="ctr"/>
        <c:lblOffset val="100"/>
        <c:noMultiLvlLbl val="0"/>
      </c:catAx>
      <c:valAx>
        <c:axId val="4297382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429733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0BAB28-32FD-40D5-8D1F-7254121A98D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DF786-BF0A-4742-A046-75F592D51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74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dirty="0">
                <a:effectLst/>
                <a:latin typeface="TimesNewRomanPSMT"/>
              </a:rPr>
              <a:t>A). miR-23a-27a-24-2 and 23b-27b-24-1 cluster expression are down-regulated in PITX2c transgenic mice. microRNA array (heat map) shows the expression levels of miR-23a/b families in PITX2c-Transgenic and wild type P0 mice. B). PITX2A represses endogenous miR-23a and miR-23b in epithelial cells. LS-8 cells were co-transfected with 2.5 </a:t>
            </a:r>
            <a:r>
              <a:rPr lang="el-GR" sz="1800" dirty="0">
                <a:effectLst/>
                <a:latin typeface="TimesNewRomanPSMT"/>
              </a:rPr>
              <a:t>μ</a:t>
            </a:r>
            <a:r>
              <a:rPr lang="en-US" sz="1800" dirty="0">
                <a:effectLst/>
                <a:latin typeface="TimesNewRomanPSMT"/>
              </a:rPr>
              <a:t>g of either the pcDNA-PITX2A, or the empty plasmid pcDNA3.1(Control). Cells were incubated for 48 hours, and then total RNAs were isolated for q-PCR assay. The miR-23a or miR-23b expression level in cells transfected with PITX2A were normalized to cells transfected with empty vector. C). Schematic representation and location of the Pitx2 binding site in the pre-miR-23a-27a-24-2 promoter. Red arrow indicates the region containing a conserved Pitx2 binding element (TCATCC). The blue arrow indicates a region which lacks Pitx2 consensus binding motif and was used as negative control as shown in Figure 4F. D). The PITX2 binding element of the mouse pre-miR-23a-27a-24-2 promoter was mapped to a highly conserved region among mouse, monkey, dog, human, and rat. The red box indicates the PCR amplified region on pre-miR-23a-27a-24-2 promoter in (C). E). </a:t>
            </a:r>
            <a:r>
              <a:rPr lang="en-US" sz="1800" dirty="0" err="1">
                <a:effectLst/>
                <a:latin typeface="TimesNewRomanPSMT"/>
              </a:rPr>
              <a:t>ChIP</a:t>
            </a:r>
            <a:r>
              <a:rPr lang="en-US" sz="1800" dirty="0">
                <a:effectLst/>
                <a:latin typeface="TimesNewRomanPSMT"/>
              </a:rPr>
              <a:t> of endogenous Pitx2 binding to the chromatin region approximately 8600bp upstream of pre-miR-23a-27a-24-2 transcript in LS-8 cells. F). Control </a:t>
            </a:r>
            <a:r>
              <a:rPr lang="en-US" sz="1800" dirty="0" err="1">
                <a:effectLst/>
                <a:latin typeface="TimesNewRomanPSMT"/>
              </a:rPr>
              <a:t>ChIP</a:t>
            </a:r>
            <a:r>
              <a:rPr lang="en-US" sz="1800" dirty="0">
                <a:effectLst/>
                <a:latin typeface="TimesNewRomanPSMT"/>
              </a:rPr>
              <a:t> using the Pitx2 antibody and primers to a 9.9kb upstream region of the pre- miR-23a-27a-24-2 transcript. This chromatin does not contain a Pitx2 binding site G). Inhibition of the miR-23a-27a-24-2 cluster promoter by PITX2. 1Kb miR-23a-27a-24-2 enhancer fragment which contains this binding element was cloned into the </a:t>
            </a:r>
            <a:r>
              <a:rPr lang="en-US" sz="1800" dirty="0" err="1">
                <a:effectLst/>
                <a:latin typeface="TimesNewRomanPSMT"/>
              </a:rPr>
              <a:t>pTK</a:t>
            </a:r>
            <a:r>
              <a:rPr lang="en-US" sz="1800" dirty="0">
                <a:effectLst/>
                <a:latin typeface="TimesNewRomanPSMT"/>
              </a:rPr>
              <a:t>-Luc reporter vector.LS-8 cells were transfected with 5 </a:t>
            </a:r>
            <a:r>
              <a:rPr lang="el-GR" sz="1800" dirty="0">
                <a:effectLst/>
                <a:latin typeface="TimesNewRomanPSMT"/>
              </a:rPr>
              <a:t>μ</a:t>
            </a:r>
            <a:r>
              <a:rPr lang="en-US" sz="1800" dirty="0">
                <a:effectLst/>
                <a:latin typeface="TimesNewRomanPSMT"/>
              </a:rPr>
              <a:t>g miR-23a-27a-24-2 cluster promoter luciferase reporter constructs. The cells were co-transfected with 2.5 </a:t>
            </a:r>
            <a:r>
              <a:rPr lang="el-GR" sz="1800" dirty="0">
                <a:effectLst/>
                <a:latin typeface="TimesNewRomanPSMT"/>
              </a:rPr>
              <a:t>μ</a:t>
            </a:r>
            <a:r>
              <a:rPr lang="en-US" sz="1800" dirty="0">
                <a:effectLst/>
                <a:latin typeface="TimesNewRomanPSMT"/>
              </a:rPr>
              <a:t>g of either the pcDNA-PITX2A, or the empty plasmid as a control (pcDNA3.1). 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EDF786-BF0A-4742-A046-75F592D515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5624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670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138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108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977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842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894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240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826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11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111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FB428-A5BF-4724-B039-F34EC365BF82}" type="datetimeFigureOut">
              <a:rPr lang="en-US" smtClean="0"/>
              <a:t>10/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1E5BB-2F6B-4C14-B40A-271005FA8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20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7.ti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chart" Target="../charts/chart1.xml"/><Relationship Id="rId5" Type="http://schemas.openxmlformats.org/officeDocument/2006/relationships/image" Target="../media/image3.tiff"/><Relationship Id="rId10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Box 123">
            <a:extLst>
              <a:ext uri="{FF2B5EF4-FFF2-40B4-BE49-F238E27FC236}">
                <a16:creationId xmlns:a16="http://schemas.microsoft.com/office/drawing/2014/main" id="{718E5C57-9A60-469D-B651-08D080847DEA}"/>
              </a:ext>
            </a:extLst>
          </p:cNvPr>
          <p:cNvSpPr txBox="1"/>
          <p:nvPr/>
        </p:nvSpPr>
        <p:spPr>
          <a:xfrm>
            <a:off x="3768436" y="364837"/>
            <a:ext cx="45833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Helvetica" pitchFamily="2" charset="0"/>
                <a:cs typeface="Helvetica" panose="020B0604020202020204" pitchFamily="34" charset="0"/>
              </a:rPr>
              <a:t>Whsc1 is associated with </a:t>
            </a:r>
            <a:r>
              <a:rPr lang="en-US" altLang="zh-CN" sz="1200" b="1" i="1" dirty="0" err="1">
                <a:latin typeface="Helvetica" pitchFamily="2" charset="0"/>
                <a:cs typeface="Helvetica" panose="020B0604020202020204" pitchFamily="34" charset="0"/>
              </a:rPr>
              <a:t>Amelogenin</a:t>
            </a:r>
            <a:r>
              <a:rPr lang="en-US" altLang="zh-CN" sz="1200" b="1" dirty="0">
                <a:latin typeface="Helvetica" pitchFamily="2" charset="0"/>
                <a:cs typeface="Helvetica" panose="020B0604020202020204" pitchFamily="34" charset="0"/>
              </a:rPr>
              <a:t> and </a:t>
            </a:r>
            <a:r>
              <a:rPr lang="en-US" altLang="zh-CN" sz="1200" b="1" i="1" dirty="0">
                <a:latin typeface="Helvetica" pitchFamily="2" charset="0"/>
                <a:cs typeface="Helvetica" panose="020B0604020202020204" pitchFamily="34" charset="0"/>
              </a:rPr>
              <a:t>Sox2</a:t>
            </a:r>
            <a:r>
              <a:rPr lang="en-US" altLang="zh-CN" sz="1200" b="1" dirty="0">
                <a:latin typeface="Helvetica" pitchFamily="2" charset="0"/>
                <a:cs typeface="Helvetica" panose="020B0604020202020204" pitchFamily="34" charset="0"/>
              </a:rPr>
              <a:t> promoters  </a:t>
            </a:r>
            <a:endParaRPr lang="en-US" sz="1200" b="1" dirty="0">
              <a:latin typeface="Helvetica" pitchFamily="2" charset="0"/>
              <a:cs typeface="Helvetica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58F0B6E-0E13-26EF-B3B7-1E10486B9C18}"/>
              </a:ext>
            </a:extLst>
          </p:cNvPr>
          <p:cNvSpPr txBox="1"/>
          <p:nvPr/>
        </p:nvSpPr>
        <p:spPr>
          <a:xfrm>
            <a:off x="9320217" y="335622"/>
            <a:ext cx="1654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Helvetica" pitchFamily="2" charset="0"/>
              </a:rPr>
              <a:t>Su</a:t>
            </a:r>
            <a:r>
              <a:rPr lang="en-US" sz="1200" dirty="0">
                <a:latin typeface="Helvetica" pitchFamily="2" charset="0"/>
              </a:rPr>
              <a:t> et al., Suppl Fig. 3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DE2C6EC-4FB9-EFAA-ADEE-679212F36BA4}"/>
              </a:ext>
            </a:extLst>
          </p:cNvPr>
          <p:cNvGrpSpPr/>
          <p:nvPr/>
        </p:nvGrpSpPr>
        <p:grpSpPr>
          <a:xfrm>
            <a:off x="369869" y="1095710"/>
            <a:ext cx="5339849" cy="3115284"/>
            <a:chOff x="369869" y="1095710"/>
            <a:chExt cx="5339849" cy="3115284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54D4DB01-8D74-9A48-C71F-1F5A99CB0623}"/>
                </a:ext>
              </a:extLst>
            </p:cNvPr>
            <p:cNvGrpSpPr/>
            <p:nvPr/>
          </p:nvGrpSpPr>
          <p:grpSpPr>
            <a:xfrm>
              <a:off x="571084" y="1095710"/>
              <a:ext cx="5138634" cy="3115284"/>
              <a:chOff x="211489" y="2893688"/>
              <a:chExt cx="5138634" cy="3115284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2BDAA1D-A9D5-4A84-A939-B84CD9714D9F}"/>
                  </a:ext>
                </a:extLst>
              </p:cNvPr>
              <p:cNvSpPr txBox="1"/>
              <p:nvPr/>
            </p:nvSpPr>
            <p:spPr>
              <a:xfrm>
                <a:off x="211489" y="2893688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Helvetica" pitchFamily="2" charset="0"/>
                    <a:cs typeface="Helvetica"/>
                  </a:rPr>
                  <a:t>A</a:t>
                </a:r>
              </a:p>
            </p:txBody>
          </p:sp>
          <p:pic>
            <p:nvPicPr>
              <p:cNvPr id="106" name="Picture 105">
                <a:extLst>
                  <a:ext uri="{FF2B5EF4-FFF2-40B4-BE49-F238E27FC236}">
                    <a16:creationId xmlns:a16="http://schemas.microsoft.com/office/drawing/2014/main" id="{D1763850-1098-4A9E-B084-F1EBA0EBC5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5497" t="3243" r="1148"/>
              <a:stretch/>
            </p:blipFill>
            <p:spPr>
              <a:xfrm>
                <a:off x="2674146" y="3719378"/>
                <a:ext cx="2328903" cy="10813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8" name="Picture 107">
                <a:extLst>
                  <a:ext uri="{FF2B5EF4-FFF2-40B4-BE49-F238E27FC236}">
                    <a16:creationId xmlns:a16="http://schemas.microsoft.com/office/drawing/2014/main" id="{5955289B-BDA5-C18B-E355-C8D65346B4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3312" t="2450" r="3745" b="-1"/>
              <a:stretch/>
            </p:blipFill>
            <p:spPr>
              <a:xfrm flipH="1">
                <a:off x="2675595" y="4984837"/>
                <a:ext cx="2317417" cy="102413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109" name="Group 108">
                <a:extLst>
                  <a:ext uri="{FF2B5EF4-FFF2-40B4-BE49-F238E27FC236}">
                    <a16:creationId xmlns:a16="http://schemas.microsoft.com/office/drawing/2014/main" id="{E2B4F763-04B2-C6DC-C3D7-9CB69A2E91E2}"/>
                  </a:ext>
                </a:extLst>
              </p:cNvPr>
              <p:cNvGrpSpPr/>
              <p:nvPr/>
            </p:nvGrpSpPr>
            <p:grpSpPr>
              <a:xfrm>
                <a:off x="1859215" y="3634191"/>
                <a:ext cx="833787" cy="276999"/>
                <a:chOff x="2021269" y="3275315"/>
                <a:chExt cx="469005" cy="155812"/>
              </a:xfrm>
            </p:grpSpPr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E9D6131A-F8C6-7DEB-6887-D8A0660C4F0D}"/>
                    </a:ext>
                  </a:extLst>
                </p:cNvPr>
                <p:cNvSpPr txBox="1"/>
                <p:nvPr/>
              </p:nvSpPr>
              <p:spPr>
                <a:xfrm>
                  <a:off x="2021269" y="3275315"/>
                  <a:ext cx="469005" cy="15581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400bp</a:t>
                  </a:r>
                </a:p>
              </p:txBody>
            </p:sp>
            <p:cxnSp>
              <p:nvCxnSpPr>
                <p:cNvPr id="111" name="Straight Connector 110">
                  <a:extLst>
                    <a:ext uri="{FF2B5EF4-FFF2-40B4-BE49-F238E27FC236}">
                      <a16:creationId xmlns:a16="http://schemas.microsoft.com/office/drawing/2014/main" id="{4A36A4CF-22EF-4A41-E451-437CD9C2D0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38987" y="3366170"/>
                  <a:ext cx="127616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2" name="Group 111">
                <a:extLst>
                  <a:ext uri="{FF2B5EF4-FFF2-40B4-BE49-F238E27FC236}">
                    <a16:creationId xmlns:a16="http://schemas.microsoft.com/office/drawing/2014/main" id="{85F39CD6-4380-6CAD-4E61-0A03408781E5}"/>
                  </a:ext>
                </a:extLst>
              </p:cNvPr>
              <p:cNvGrpSpPr/>
              <p:nvPr/>
            </p:nvGrpSpPr>
            <p:grpSpPr>
              <a:xfrm>
                <a:off x="1849220" y="3905833"/>
                <a:ext cx="833787" cy="276999"/>
                <a:chOff x="2015489" y="3282808"/>
                <a:chExt cx="469005" cy="155812"/>
              </a:xfrm>
            </p:grpSpPr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5A296B79-0CC6-B783-28B3-3D22C37EAB76}"/>
                    </a:ext>
                  </a:extLst>
                </p:cNvPr>
                <p:cNvSpPr txBox="1"/>
                <p:nvPr/>
              </p:nvSpPr>
              <p:spPr>
                <a:xfrm>
                  <a:off x="2015489" y="3282808"/>
                  <a:ext cx="469005" cy="15581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00bp</a:t>
                  </a:r>
                </a:p>
              </p:txBody>
            </p:sp>
            <p:cxnSp>
              <p:nvCxnSpPr>
                <p:cNvPr id="114" name="Straight Connector 113">
                  <a:extLst>
                    <a:ext uri="{FF2B5EF4-FFF2-40B4-BE49-F238E27FC236}">
                      <a16:creationId xmlns:a16="http://schemas.microsoft.com/office/drawing/2014/main" id="{B178304D-3612-0F03-5250-D7DE5BFB00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38987" y="3366170"/>
                  <a:ext cx="127616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5" name="Group 114">
                <a:extLst>
                  <a:ext uri="{FF2B5EF4-FFF2-40B4-BE49-F238E27FC236}">
                    <a16:creationId xmlns:a16="http://schemas.microsoft.com/office/drawing/2014/main" id="{3577585D-8D96-4A52-FEE9-2DC370EADE3A}"/>
                  </a:ext>
                </a:extLst>
              </p:cNvPr>
              <p:cNvGrpSpPr/>
              <p:nvPr/>
            </p:nvGrpSpPr>
            <p:grpSpPr>
              <a:xfrm>
                <a:off x="1859213" y="4281024"/>
                <a:ext cx="833787" cy="276999"/>
                <a:chOff x="2021268" y="3282808"/>
                <a:chExt cx="469005" cy="155812"/>
              </a:xfrm>
            </p:grpSpPr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D333D9AB-C395-17E5-2E36-B7727343EA80}"/>
                    </a:ext>
                  </a:extLst>
                </p:cNvPr>
                <p:cNvSpPr txBox="1"/>
                <p:nvPr/>
              </p:nvSpPr>
              <p:spPr>
                <a:xfrm>
                  <a:off x="2021268" y="3282808"/>
                  <a:ext cx="469005" cy="15581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00bp</a:t>
                  </a:r>
                </a:p>
              </p:txBody>
            </p:sp>
            <p:cxnSp>
              <p:nvCxnSpPr>
                <p:cNvPr id="117" name="Straight Connector 116">
                  <a:extLst>
                    <a:ext uri="{FF2B5EF4-FFF2-40B4-BE49-F238E27FC236}">
                      <a16:creationId xmlns:a16="http://schemas.microsoft.com/office/drawing/2014/main" id="{C79C217B-A4BF-7EB1-6020-79004E61C4C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38987" y="3366170"/>
                  <a:ext cx="127616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12C92638-2E8F-3B36-7833-B1ED8DB2E90B}"/>
                  </a:ext>
                </a:extLst>
              </p:cNvPr>
              <p:cNvGrpSpPr/>
              <p:nvPr/>
            </p:nvGrpSpPr>
            <p:grpSpPr>
              <a:xfrm>
                <a:off x="1860703" y="4892030"/>
                <a:ext cx="833787" cy="276999"/>
                <a:chOff x="2021268" y="3275314"/>
                <a:chExt cx="469005" cy="155812"/>
              </a:xfrm>
            </p:grpSpPr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C5E482FC-09B4-9DB9-1369-2F6E5B1C2607}"/>
                    </a:ext>
                  </a:extLst>
                </p:cNvPr>
                <p:cNvSpPr txBox="1"/>
                <p:nvPr/>
              </p:nvSpPr>
              <p:spPr>
                <a:xfrm>
                  <a:off x="2021268" y="3275314"/>
                  <a:ext cx="469005" cy="15581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400bp</a:t>
                  </a:r>
                </a:p>
              </p:txBody>
            </p:sp>
            <p:cxnSp>
              <p:nvCxnSpPr>
                <p:cNvPr id="120" name="Straight Connector 119">
                  <a:extLst>
                    <a:ext uri="{FF2B5EF4-FFF2-40B4-BE49-F238E27FC236}">
                      <a16:creationId xmlns:a16="http://schemas.microsoft.com/office/drawing/2014/main" id="{73289ECC-A064-751F-0D73-3647394C7B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38987" y="3366170"/>
                  <a:ext cx="127616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4D5D4E1B-B2CA-8AEA-2093-531E69F2731F}"/>
                  </a:ext>
                </a:extLst>
              </p:cNvPr>
              <p:cNvGrpSpPr/>
              <p:nvPr/>
            </p:nvGrpSpPr>
            <p:grpSpPr>
              <a:xfrm>
                <a:off x="1860984" y="5187268"/>
                <a:ext cx="833787" cy="276999"/>
                <a:chOff x="2021268" y="3277029"/>
                <a:chExt cx="469005" cy="155812"/>
              </a:xfrm>
            </p:grpSpPr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FB52FF61-022C-BEF0-966B-7A0CE9EA4D04}"/>
                    </a:ext>
                  </a:extLst>
                </p:cNvPr>
                <p:cNvSpPr txBox="1"/>
                <p:nvPr/>
              </p:nvSpPr>
              <p:spPr>
                <a:xfrm>
                  <a:off x="2021268" y="3277029"/>
                  <a:ext cx="469005" cy="15581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00bp</a:t>
                  </a:r>
                </a:p>
              </p:txBody>
            </p:sp>
            <p:cxnSp>
              <p:nvCxnSpPr>
                <p:cNvPr id="123" name="Straight Connector 122">
                  <a:extLst>
                    <a:ext uri="{FF2B5EF4-FFF2-40B4-BE49-F238E27FC236}">
                      <a16:creationId xmlns:a16="http://schemas.microsoft.com/office/drawing/2014/main" id="{8A792A83-BC7E-7AEF-9087-D486DB5E9C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38987" y="3366170"/>
                  <a:ext cx="127616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5" name="Group 124">
                <a:extLst>
                  <a:ext uri="{FF2B5EF4-FFF2-40B4-BE49-F238E27FC236}">
                    <a16:creationId xmlns:a16="http://schemas.microsoft.com/office/drawing/2014/main" id="{FDE4B236-AA60-2191-65B9-C5BEA42B7D10}"/>
                  </a:ext>
                </a:extLst>
              </p:cNvPr>
              <p:cNvGrpSpPr/>
              <p:nvPr/>
            </p:nvGrpSpPr>
            <p:grpSpPr>
              <a:xfrm>
                <a:off x="1860703" y="5555799"/>
                <a:ext cx="833787" cy="276999"/>
                <a:chOff x="2021268" y="3282807"/>
                <a:chExt cx="469005" cy="155812"/>
              </a:xfrm>
            </p:grpSpPr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978C8E01-86FE-E1CE-1174-D51BA82DF7BE}"/>
                    </a:ext>
                  </a:extLst>
                </p:cNvPr>
                <p:cNvSpPr txBox="1"/>
                <p:nvPr/>
              </p:nvSpPr>
              <p:spPr>
                <a:xfrm>
                  <a:off x="2021268" y="3282807"/>
                  <a:ext cx="469005" cy="15581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2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00bp</a:t>
                  </a:r>
                </a:p>
              </p:txBody>
            </p:sp>
            <p:cxnSp>
              <p:nvCxnSpPr>
                <p:cNvPr id="127" name="Straight Connector 126">
                  <a:extLst>
                    <a:ext uri="{FF2B5EF4-FFF2-40B4-BE49-F238E27FC236}">
                      <a16:creationId xmlns:a16="http://schemas.microsoft.com/office/drawing/2014/main" id="{F91AFEEA-2827-9151-5C03-80E42B9580E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38987" y="3366170"/>
                  <a:ext cx="127616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F541B0F0-1676-F61E-3352-4A39D8D39391}"/>
                  </a:ext>
                </a:extLst>
              </p:cNvPr>
              <p:cNvSpPr txBox="1"/>
              <p:nvPr/>
            </p:nvSpPr>
            <p:spPr>
              <a:xfrm rot="18900000">
                <a:off x="4548879" y="3336447"/>
                <a:ext cx="65939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nput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FE6C34DC-3DB9-5411-5264-278A8E9D06F0}"/>
                  </a:ext>
                </a:extLst>
              </p:cNvPr>
              <p:cNvSpPr txBox="1"/>
              <p:nvPr/>
            </p:nvSpPr>
            <p:spPr>
              <a:xfrm rot="18900000">
                <a:off x="4107357" y="3136774"/>
                <a:ext cx="124276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No Ab control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121935CD-46AF-C396-AC8D-8D24FACEB0DE}"/>
                  </a:ext>
                </a:extLst>
              </p:cNvPr>
              <p:cNvSpPr txBox="1"/>
              <p:nvPr/>
            </p:nvSpPr>
            <p:spPr>
              <a:xfrm rot="18900000">
                <a:off x="3708546" y="3214337"/>
                <a:ext cx="106714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gG control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39FA6322-18BE-6151-B197-36B681003DFE}"/>
                  </a:ext>
                </a:extLst>
              </p:cNvPr>
              <p:cNvSpPr txBox="1"/>
              <p:nvPr/>
            </p:nvSpPr>
            <p:spPr>
              <a:xfrm rot="18900000">
                <a:off x="3354685" y="3214696"/>
                <a:ext cx="1028645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ChIP-</a:t>
                </a:r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Pitx2</a:t>
                </a: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E5BC3C87-6DF4-F4FD-BF91-62B05810E7C6}"/>
                  </a:ext>
                </a:extLst>
              </p:cNvPr>
              <p:cNvSpPr txBox="1"/>
              <p:nvPr/>
            </p:nvSpPr>
            <p:spPr>
              <a:xfrm rot="18900000">
                <a:off x="2941897" y="3191162"/>
                <a:ext cx="115535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ChIP-Whsc1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9BE9C55C-62F8-B38D-7E12-84507C40F8D6}"/>
                  </a:ext>
                </a:extLst>
              </p:cNvPr>
              <p:cNvSpPr txBox="1"/>
              <p:nvPr/>
            </p:nvSpPr>
            <p:spPr>
              <a:xfrm rot="18900000">
                <a:off x="2543882" y="3201054"/>
                <a:ext cx="113579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PCR control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61C4DBD7-C991-5583-D201-03DBE5021DC5}"/>
                  </a:ext>
                </a:extLst>
              </p:cNvPr>
              <p:cNvSpPr txBox="1"/>
              <p:nvPr/>
            </p:nvSpPr>
            <p:spPr>
              <a:xfrm flipH="1">
                <a:off x="1571946" y="4652335"/>
                <a:ext cx="7541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125C318A-74E1-CE4F-495B-400DD9874D78}"/>
                  </a:ext>
                </a:extLst>
              </p:cNvPr>
              <p:cNvSpPr txBox="1"/>
              <p:nvPr/>
            </p:nvSpPr>
            <p:spPr>
              <a:xfrm flipH="1">
                <a:off x="1033368" y="3174825"/>
                <a:ext cx="18742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i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Amelogenin</a:t>
                </a:r>
                <a:r>
                  <a:rPr lang="en-US" sz="1200" b="1" i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promoter</a:t>
                </a: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107E44BE-1878-D3C5-0A39-AE7ACC885531}"/>
                </a:ext>
              </a:extLst>
            </p:cNvPr>
            <p:cNvGrpSpPr/>
            <p:nvPr/>
          </p:nvGrpSpPr>
          <p:grpSpPr>
            <a:xfrm>
              <a:off x="369869" y="2218760"/>
              <a:ext cx="1559966" cy="944893"/>
              <a:chOff x="1399154" y="5962010"/>
              <a:chExt cx="1206013" cy="773765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1B44DE77-C882-DC67-5857-77F47CDDFC31}"/>
                  </a:ext>
                </a:extLst>
              </p:cNvPr>
              <p:cNvSpPr txBox="1"/>
              <p:nvPr/>
            </p:nvSpPr>
            <p:spPr>
              <a:xfrm>
                <a:off x="1621350" y="5962010"/>
                <a:ext cx="416994" cy="226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>
                        <a:lumMod val="50000"/>
                      </a:schemeClr>
                    </a:solidFill>
                    <a:latin typeface="Helvetica" pitchFamily="2" charset="0"/>
                    <a:cs typeface="Helvetica" panose="020B0604020202020204" pitchFamily="34" charset="0"/>
                  </a:rPr>
                  <a:t>con</a:t>
                </a:r>
              </a:p>
            </p:txBody>
          </p:sp>
          <p:cxnSp>
            <p:nvCxnSpPr>
              <p:cNvPr id="5" name="Straight Connector 4">
                <a:extLst>
                  <a:ext uri="{FF2B5EF4-FFF2-40B4-BE49-F238E27FC236}">
                    <a16:creationId xmlns:a16="http://schemas.microsoft.com/office/drawing/2014/main" id="{D01C9FC2-451A-3430-1370-1BB7AB59A4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6235" y="6153488"/>
                <a:ext cx="0" cy="370657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74EA4320-5EB4-45EA-75DD-A75F3C9DD97E}"/>
                  </a:ext>
                </a:extLst>
              </p:cNvPr>
              <p:cNvSpPr/>
              <p:nvPr/>
            </p:nvSpPr>
            <p:spPr>
              <a:xfrm>
                <a:off x="1784066" y="6203503"/>
                <a:ext cx="73023" cy="12917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Helvetica" pitchFamily="2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DF295DB-D7BF-77AE-F22B-F5EC669584C6}"/>
                  </a:ext>
                </a:extLst>
              </p:cNvPr>
              <p:cNvSpPr txBox="1"/>
              <p:nvPr/>
            </p:nvSpPr>
            <p:spPr>
              <a:xfrm>
                <a:off x="1399154" y="6508943"/>
                <a:ext cx="777931" cy="226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 i="1" dirty="0">
                    <a:latin typeface="Helvetica" pitchFamily="2" charset="0"/>
                    <a:cs typeface="Helvetica" panose="020B0604020202020204" pitchFamily="34" charset="0"/>
                  </a:rPr>
                  <a:t> </a:t>
                </a:r>
                <a:r>
                  <a:rPr lang="en-US" sz="1200" b="1" i="1" dirty="0" err="1">
                    <a:latin typeface="Helvetica" pitchFamily="2" charset="0"/>
                    <a:cs typeface="Helvetica" panose="020B0604020202020204" pitchFamily="34" charset="0"/>
                  </a:rPr>
                  <a:t>Amelx</a:t>
                </a:r>
                <a:r>
                  <a:rPr lang="en-US" sz="1200" b="1" dirty="0">
                    <a:latin typeface="Helvetica" pitchFamily="2" charset="0"/>
                    <a:cs typeface="Helvetica" panose="020B0604020202020204" pitchFamily="34" charset="0"/>
                  </a:rPr>
                  <a:t> pro</a:t>
                </a:r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66DF6EDE-AFE8-9EF7-1BBF-0D07BAF148AF}"/>
                  </a:ext>
                </a:extLst>
              </p:cNvPr>
              <p:cNvSpPr/>
              <p:nvPr/>
            </p:nvSpPr>
            <p:spPr>
              <a:xfrm>
                <a:off x="2131938" y="6425654"/>
                <a:ext cx="389374" cy="20966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Helvetica" pitchFamily="2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14949B8-1D7F-30FD-2F32-533C9C59C2AF}"/>
                  </a:ext>
                </a:extLst>
              </p:cNvPr>
              <p:cNvSpPr txBox="1"/>
              <p:nvPr/>
            </p:nvSpPr>
            <p:spPr>
              <a:xfrm>
                <a:off x="2040449" y="6205055"/>
                <a:ext cx="564718" cy="226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Helvetica" pitchFamily="2" charset="0"/>
                    <a:cs typeface="Helvetica" panose="020B0604020202020204" pitchFamily="34" charset="0"/>
                  </a:rPr>
                  <a:t>Exon 1</a:t>
                </a:r>
              </a:p>
            </p:txBody>
          </p: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FB427F2B-4C02-1B01-24DF-6C78421778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83298" y="6532266"/>
                <a:ext cx="54864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E2CB0FF-527F-3994-7E86-9C6C7DAF6AAD}"/>
                  </a:ext>
                </a:extLst>
              </p:cNvPr>
              <p:cNvSpPr txBox="1"/>
              <p:nvPr/>
            </p:nvSpPr>
            <p:spPr>
              <a:xfrm>
                <a:off x="1483020" y="6134042"/>
                <a:ext cx="631665" cy="226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Helvetica" pitchFamily="2" charset="0"/>
                    <a:cs typeface="Helvetica" panose="020B0604020202020204" pitchFamily="34" charset="0"/>
                  </a:rPr>
                  <a:t>-3.4</a:t>
                </a:r>
                <a:r>
                  <a:rPr lang="zh-CN" altLang="en-US" sz="1200" b="1" dirty="0">
                    <a:latin typeface="Helvetica" pitchFamily="2" charset="0"/>
                    <a:cs typeface="Helvetica" panose="020B0604020202020204" pitchFamily="34" charset="0"/>
                  </a:rPr>
                  <a:t> </a:t>
                </a:r>
                <a:r>
                  <a:rPr lang="en-US" sz="1200" b="1" dirty="0" err="1">
                    <a:latin typeface="Helvetica" pitchFamily="2" charset="0"/>
                    <a:cs typeface="Helvetica" panose="020B0604020202020204" pitchFamily="34" charset="0"/>
                  </a:rPr>
                  <a:t>kbp</a:t>
                </a:r>
                <a:endParaRPr lang="en-US" sz="1200" b="1" dirty="0">
                  <a:latin typeface="Helvetica" pitchFamily="2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B7DE6EAC-7866-733C-4652-78BA86A0E720}"/>
                  </a:ext>
                </a:extLst>
              </p:cNvPr>
              <p:cNvGrpSpPr/>
              <p:nvPr/>
            </p:nvGrpSpPr>
            <p:grpSpPr>
              <a:xfrm>
                <a:off x="1777763" y="6241566"/>
                <a:ext cx="349647" cy="281554"/>
                <a:chOff x="5063053" y="4212150"/>
                <a:chExt cx="349647" cy="281554"/>
              </a:xfrm>
            </p:grpSpPr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D43F059D-BD4D-0B5C-7EE2-3076B1650C97}"/>
                    </a:ext>
                  </a:extLst>
                </p:cNvPr>
                <p:cNvCxnSpPr/>
                <p:nvPr/>
              </p:nvCxnSpPr>
              <p:spPr>
                <a:xfrm>
                  <a:off x="5168623" y="4394164"/>
                  <a:ext cx="0" cy="995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3E9B0173-0922-5F10-D4BC-B4E4B58A0044}"/>
                    </a:ext>
                  </a:extLst>
                </p:cNvPr>
                <p:cNvSpPr txBox="1"/>
                <p:nvPr/>
              </p:nvSpPr>
              <p:spPr>
                <a:xfrm>
                  <a:off x="5063053" y="4212150"/>
                  <a:ext cx="349647" cy="226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en-US" sz="1200" b="1" dirty="0">
                      <a:solidFill>
                        <a:srgbClr val="000000"/>
                      </a:solidFill>
                      <a:latin typeface="Helvetica" pitchFamily="2" charset="0"/>
                    </a:rPr>
                    <a:t>#</a:t>
                  </a:r>
                  <a:endParaRPr lang="en-US" sz="1200" b="1" dirty="0">
                    <a:latin typeface="Helvetica" pitchFamily="2" charset="0"/>
                  </a:endParaRPr>
                </a:p>
              </p:txBody>
            </p:sp>
          </p:grpSp>
        </p:grp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B674A4C1-A374-3CDD-C402-92B1D50E6046}"/>
              </a:ext>
            </a:extLst>
          </p:cNvPr>
          <p:cNvSpPr txBox="1"/>
          <p:nvPr/>
        </p:nvSpPr>
        <p:spPr>
          <a:xfrm>
            <a:off x="3205537" y="233223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0B5CB5FF-5298-F9B1-459F-4B1016053425}"/>
              </a:ext>
            </a:extLst>
          </p:cNvPr>
          <p:cNvGrpSpPr/>
          <p:nvPr/>
        </p:nvGrpSpPr>
        <p:grpSpPr>
          <a:xfrm>
            <a:off x="5578865" y="999003"/>
            <a:ext cx="3920779" cy="3223174"/>
            <a:chOff x="6174766" y="988729"/>
            <a:chExt cx="3920779" cy="3223174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BBFECFC-BE0E-AA47-53E9-0FE8CA8CA76E}"/>
                </a:ext>
              </a:extLst>
            </p:cNvPr>
            <p:cNvSpPr txBox="1"/>
            <p:nvPr/>
          </p:nvSpPr>
          <p:spPr>
            <a:xfrm>
              <a:off x="6211462" y="98872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  <a:cs typeface="Helvetica"/>
                </a:rPr>
                <a:t>C</a:t>
              </a: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28F3DAA1-31E6-2C22-D066-9B59F59A248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785959" y="3151526"/>
              <a:ext cx="2216639" cy="968411"/>
            </a:xfrm>
            <a:prstGeom prst="rect">
              <a:avLst/>
            </a:prstGeom>
            <a:ln>
              <a:noFill/>
            </a:ln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797C0AF-CC82-DA4F-7DA2-F2E42BE3687A}"/>
                </a:ext>
              </a:extLst>
            </p:cNvPr>
            <p:cNvSpPr txBox="1"/>
            <p:nvPr/>
          </p:nvSpPr>
          <p:spPr>
            <a:xfrm rot="18900000">
              <a:off x="9363932" y="1498824"/>
              <a:ext cx="73161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put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2A4953A-DBEA-3389-852A-2766DBF8E8D2}"/>
                </a:ext>
              </a:extLst>
            </p:cNvPr>
            <p:cNvSpPr txBox="1"/>
            <p:nvPr/>
          </p:nvSpPr>
          <p:spPr>
            <a:xfrm rot="18900000">
              <a:off x="8836695" y="1359861"/>
              <a:ext cx="123201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o Ab control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0980DC0-2619-119B-BE73-520F8B989ACF}"/>
                </a:ext>
              </a:extLst>
            </p:cNvPr>
            <p:cNvSpPr txBox="1"/>
            <p:nvPr/>
          </p:nvSpPr>
          <p:spPr>
            <a:xfrm rot="18900000">
              <a:off x="8487339" y="1418237"/>
              <a:ext cx="101654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gG control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46303A3-B6CF-4C2F-96C9-4CFF2B29F247}"/>
                </a:ext>
              </a:extLst>
            </p:cNvPr>
            <p:cNvSpPr txBox="1"/>
            <p:nvPr/>
          </p:nvSpPr>
          <p:spPr>
            <a:xfrm rot="18900000">
              <a:off x="8031770" y="1310166"/>
              <a:ext cx="138953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hIP-H3K36me2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A3347F5-B39C-2505-DFB6-277DFBF939A3}"/>
                </a:ext>
              </a:extLst>
            </p:cNvPr>
            <p:cNvSpPr txBox="1"/>
            <p:nvPr/>
          </p:nvSpPr>
          <p:spPr>
            <a:xfrm rot="18900000">
              <a:off x="7747748" y="1380236"/>
              <a:ext cx="115517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CR control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0747A04-5C9D-E205-7D50-E815E27EA667}"/>
                </a:ext>
              </a:extLst>
            </p:cNvPr>
            <p:cNvSpPr txBox="1"/>
            <p:nvPr/>
          </p:nvSpPr>
          <p:spPr>
            <a:xfrm>
              <a:off x="7001066" y="1874553"/>
              <a:ext cx="78653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300bp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BFE51DE5-0D91-A79D-5908-9E825C4ADC64}"/>
                </a:ext>
              </a:extLst>
            </p:cNvPr>
            <p:cNvCxnSpPr>
              <a:cxnSpLocks/>
            </p:cNvCxnSpPr>
            <p:nvPr/>
          </p:nvCxnSpPr>
          <p:spPr>
            <a:xfrm>
              <a:off x="7560536" y="2022626"/>
              <a:ext cx="21401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BFAB6B2-C8E2-AE99-0F17-516B522F3BAD}"/>
                </a:ext>
              </a:extLst>
            </p:cNvPr>
            <p:cNvSpPr txBox="1"/>
            <p:nvPr/>
          </p:nvSpPr>
          <p:spPr>
            <a:xfrm>
              <a:off x="7011604" y="2264970"/>
              <a:ext cx="78653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200bp</a:t>
              </a:r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12AEA63F-B28C-B63A-C49C-13AAD083A1AB}"/>
                </a:ext>
              </a:extLst>
            </p:cNvPr>
            <p:cNvCxnSpPr>
              <a:cxnSpLocks/>
            </p:cNvCxnSpPr>
            <p:nvPr/>
          </p:nvCxnSpPr>
          <p:spPr>
            <a:xfrm>
              <a:off x="7560801" y="2404271"/>
              <a:ext cx="21401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521BD48-F145-38F6-75DD-8E41831BFD81}"/>
                </a:ext>
              </a:extLst>
            </p:cNvPr>
            <p:cNvSpPr txBox="1"/>
            <p:nvPr/>
          </p:nvSpPr>
          <p:spPr>
            <a:xfrm>
              <a:off x="7010913" y="2768133"/>
              <a:ext cx="64333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100bp</a:t>
              </a:r>
            </a:p>
          </p:txBody>
        </p: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083EFEF9-AEDE-227C-88AE-4140829B76BB}"/>
                </a:ext>
              </a:extLst>
            </p:cNvPr>
            <p:cNvCxnSpPr>
              <a:cxnSpLocks/>
            </p:cNvCxnSpPr>
            <p:nvPr/>
          </p:nvCxnSpPr>
          <p:spPr>
            <a:xfrm>
              <a:off x="7560536" y="2920264"/>
              <a:ext cx="21401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55763C8-E338-B2DF-6F18-2371C4FB4EC9}"/>
                </a:ext>
              </a:extLst>
            </p:cNvPr>
            <p:cNvSpPr txBox="1"/>
            <p:nvPr/>
          </p:nvSpPr>
          <p:spPr>
            <a:xfrm>
              <a:off x="7010913" y="3087313"/>
              <a:ext cx="78653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300bp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AA630FC9-AB98-7359-A879-8EF61BE225B5}"/>
                </a:ext>
              </a:extLst>
            </p:cNvPr>
            <p:cNvCxnSpPr>
              <a:cxnSpLocks/>
            </p:cNvCxnSpPr>
            <p:nvPr/>
          </p:nvCxnSpPr>
          <p:spPr>
            <a:xfrm>
              <a:off x="7560109" y="3238016"/>
              <a:ext cx="21401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3597A2B-BAC9-7555-FC84-991ECD98ECAB}"/>
                </a:ext>
              </a:extLst>
            </p:cNvPr>
            <p:cNvSpPr txBox="1"/>
            <p:nvPr/>
          </p:nvSpPr>
          <p:spPr>
            <a:xfrm>
              <a:off x="7011178" y="3500908"/>
              <a:ext cx="78653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200bp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04CD90BB-E926-611D-A743-08659CE2EA78}"/>
                </a:ext>
              </a:extLst>
            </p:cNvPr>
            <p:cNvCxnSpPr>
              <a:cxnSpLocks/>
            </p:cNvCxnSpPr>
            <p:nvPr/>
          </p:nvCxnSpPr>
          <p:spPr>
            <a:xfrm>
              <a:off x="7560374" y="3650483"/>
              <a:ext cx="21401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7F0519D5-5426-B33E-33FC-3ED717617F2E}"/>
                </a:ext>
              </a:extLst>
            </p:cNvPr>
            <p:cNvSpPr txBox="1"/>
            <p:nvPr/>
          </p:nvSpPr>
          <p:spPr>
            <a:xfrm>
              <a:off x="7010913" y="3934904"/>
              <a:ext cx="78653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100bp</a:t>
              </a: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A9797268-3F66-59B9-1553-6F6A01F3D3A2}"/>
                </a:ext>
              </a:extLst>
            </p:cNvPr>
            <p:cNvCxnSpPr>
              <a:cxnSpLocks/>
            </p:cNvCxnSpPr>
            <p:nvPr/>
          </p:nvCxnSpPr>
          <p:spPr>
            <a:xfrm>
              <a:off x="7560109" y="4074204"/>
              <a:ext cx="21401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C1075383-44A1-D0D7-FDD3-3DE754BF289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782541" y="1930191"/>
              <a:ext cx="2216638" cy="1095580"/>
            </a:xfrm>
            <a:prstGeom prst="rect">
              <a:avLst/>
            </a:prstGeom>
            <a:ln>
              <a:noFill/>
            </a:ln>
          </p:spPr>
        </p:pic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DDA8300-0DB7-0687-4A43-B33C2C09EB57}"/>
                </a:ext>
              </a:extLst>
            </p:cNvPr>
            <p:cNvSpPr txBox="1"/>
            <p:nvPr/>
          </p:nvSpPr>
          <p:spPr>
            <a:xfrm flipH="1">
              <a:off x="6369977" y="2940284"/>
              <a:ext cx="8221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ontrol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F3E2406-10A1-9345-9F0B-84F84B0A3FD6}"/>
                </a:ext>
              </a:extLst>
            </p:cNvPr>
            <p:cNvSpPr txBox="1"/>
            <p:nvPr/>
          </p:nvSpPr>
          <p:spPr>
            <a:xfrm flipH="1">
              <a:off x="6174766" y="1453188"/>
              <a:ext cx="17774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Amelogenin</a:t>
              </a:r>
              <a:r>
                <a:rPr lang="en-US" sz="1200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romoter</a:t>
              </a: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3DC02A98-4438-DCF8-C284-BF9B77D96D92}"/>
              </a:ext>
            </a:extLst>
          </p:cNvPr>
          <p:cNvSpPr txBox="1"/>
          <p:nvPr/>
        </p:nvSpPr>
        <p:spPr>
          <a:xfrm>
            <a:off x="6095006" y="450475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Helvetica" pitchFamily="2" charset="0"/>
                <a:cs typeface="Helvetica"/>
              </a:rPr>
              <a:t>F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C12434D6-C17A-EB38-B6DA-4C4A3057E69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1000" contrast="21000"/>
                    </a14:imgEffect>
                  </a14:imgLayer>
                </a14:imgProps>
              </a:ext>
            </a:extLst>
          </a:blip>
          <a:srcRect r="1786"/>
          <a:stretch/>
        </p:blipFill>
        <p:spPr>
          <a:xfrm>
            <a:off x="7238865" y="6592127"/>
            <a:ext cx="2135698" cy="517746"/>
          </a:xfrm>
          <a:prstGeom prst="rect">
            <a:avLst/>
          </a:prstGeom>
          <a:ln>
            <a:noFill/>
          </a:ln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90937A78-8C30-7FFC-5C75-376315E3C29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1000"/>
                    </a14:imgEffect>
                    <a14:imgEffect>
                      <a14:brightnessContrast bright="38000" contrast="3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234428" y="5438693"/>
            <a:ext cx="2140134" cy="825112"/>
          </a:xfrm>
          <a:prstGeom prst="rect">
            <a:avLst/>
          </a:prstGeom>
          <a:ln>
            <a:noFill/>
          </a:ln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C8AB1DBC-80E2-FFF2-4E7B-8E25617E71AB}"/>
              </a:ext>
            </a:extLst>
          </p:cNvPr>
          <p:cNvSpPr txBox="1"/>
          <p:nvPr/>
        </p:nvSpPr>
        <p:spPr>
          <a:xfrm>
            <a:off x="6459468" y="5575142"/>
            <a:ext cx="78653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200bp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FADBA597-D107-665D-4B92-595BA89A16C8}"/>
              </a:ext>
            </a:extLst>
          </p:cNvPr>
          <p:cNvCxnSpPr>
            <a:cxnSpLocks/>
          </p:cNvCxnSpPr>
          <p:nvPr/>
        </p:nvCxnSpPr>
        <p:spPr>
          <a:xfrm>
            <a:off x="7008664" y="5723215"/>
            <a:ext cx="21401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18CE76A2-12EC-9DD6-97E5-8234B66056C2}"/>
              </a:ext>
            </a:extLst>
          </p:cNvPr>
          <p:cNvSpPr txBox="1"/>
          <p:nvPr/>
        </p:nvSpPr>
        <p:spPr>
          <a:xfrm>
            <a:off x="6459733" y="5988738"/>
            <a:ext cx="78653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100bp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B36678E-BA4B-FB77-90B2-E52221F1745B}"/>
              </a:ext>
            </a:extLst>
          </p:cNvPr>
          <p:cNvCxnSpPr>
            <a:cxnSpLocks/>
          </p:cNvCxnSpPr>
          <p:nvPr/>
        </p:nvCxnSpPr>
        <p:spPr>
          <a:xfrm>
            <a:off x="7008929" y="6138313"/>
            <a:ext cx="21401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97A8E10A-A80C-BA0D-48D5-08CCF1CC4E77}"/>
              </a:ext>
            </a:extLst>
          </p:cNvPr>
          <p:cNvSpPr txBox="1"/>
          <p:nvPr/>
        </p:nvSpPr>
        <p:spPr>
          <a:xfrm rot="18900000">
            <a:off x="8883727" y="5049446"/>
            <a:ext cx="71440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E5211E1-3F3F-9F5B-7AAE-2E10D46D446F}"/>
              </a:ext>
            </a:extLst>
          </p:cNvPr>
          <p:cNvSpPr txBox="1"/>
          <p:nvPr/>
        </p:nvSpPr>
        <p:spPr>
          <a:xfrm rot="18900000">
            <a:off x="8383682" y="4872441"/>
            <a:ext cx="126895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No Ab control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0F72799-A069-BBEA-E16F-EB435A2B87D9}"/>
              </a:ext>
            </a:extLst>
          </p:cNvPr>
          <p:cNvSpPr txBox="1"/>
          <p:nvPr/>
        </p:nvSpPr>
        <p:spPr>
          <a:xfrm rot="18900000">
            <a:off x="7977796" y="4895111"/>
            <a:ext cx="1167641" cy="2836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IgG control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6550595-BA71-CC31-ABA4-B34D5DD79EDD}"/>
              </a:ext>
            </a:extLst>
          </p:cNvPr>
          <p:cNvSpPr txBox="1"/>
          <p:nvPr/>
        </p:nvSpPr>
        <p:spPr>
          <a:xfrm rot="18900000">
            <a:off x="7523465" y="4797618"/>
            <a:ext cx="1473705" cy="2811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hIP-H3K36me2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468239C-67CB-F112-0AD8-9956491E1073}"/>
              </a:ext>
            </a:extLst>
          </p:cNvPr>
          <p:cNvSpPr txBox="1"/>
          <p:nvPr/>
        </p:nvSpPr>
        <p:spPr>
          <a:xfrm rot="18900000">
            <a:off x="7171607" y="4898773"/>
            <a:ext cx="121600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PCR control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8DEB9AA-2002-3843-9BBA-0A52A36A11E1}"/>
              </a:ext>
            </a:extLst>
          </p:cNvPr>
          <p:cNvSpPr txBox="1"/>
          <p:nvPr/>
        </p:nvSpPr>
        <p:spPr>
          <a:xfrm>
            <a:off x="6459203" y="6503230"/>
            <a:ext cx="78653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300bp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B86BF66E-2CA9-1D21-0BB0-9B3A3452FEA7}"/>
              </a:ext>
            </a:extLst>
          </p:cNvPr>
          <p:cNvCxnSpPr>
            <a:cxnSpLocks/>
          </p:cNvCxnSpPr>
          <p:nvPr/>
        </p:nvCxnSpPr>
        <p:spPr>
          <a:xfrm>
            <a:off x="7008399" y="6651303"/>
            <a:ext cx="21401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F5F42D3B-AECA-1530-2D1F-113873697F9A}"/>
              </a:ext>
            </a:extLst>
          </p:cNvPr>
          <p:cNvSpPr txBox="1"/>
          <p:nvPr/>
        </p:nvSpPr>
        <p:spPr>
          <a:xfrm>
            <a:off x="6459468" y="6794165"/>
            <a:ext cx="78653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200bp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9BAD70F1-A381-F620-9F94-7048A79EF9A1}"/>
              </a:ext>
            </a:extLst>
          </p:cNvPr>
          <p:cNvCxnSpPr>
            <a:cxnSpLocks/>
          </p:cNvCxnSpPr>
          <p:nvPr/>
        </p:nvCxnSpPr>
        <p:spPr>
          <a:xfrm>
            <a:off x="7008664" y="6943740"/>
            <a:ext cx="21401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C28A636B-B57C-F663-A09E-B1F2CFA715DA}"/>
              </a:ext>
            </a:extLst>
          </p:cNvPr>
          <p:cNvSpPr txBox="1"/>
          <p:nvPr/>
        </p:nvSpPr>
        <p:spPr>
          <a:xfrm flipH="1">
            <a:off x="5969039" y="4970384"/>
            <a:ext cx="1407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i="1" dirty="0">
                <a:latin typeface="Helvetica" panose="020B0604020202020204" pitchFamily="34" charset="0"/>
                <a:cs typeface="Helvetica" panose="020B0604020202020204" pitchFamily="34" charset="0"/>
              </a:rPr>
              <a:t>Sox2 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Promot</a:t>
            </a:r>
            <a:r>
              <a:rPr lang="en-US" altLang="zh-CN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e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r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6ED16CF-53AC-4463-AC0F-2340A4DB1816}"/>
              </a:ext>
            </a:extLst>
          </p:cNvPr>
          <p:cNvSpPr txBox="1"/>
          <p:nvPr/>
        </p:nvSpPr>
        <p:spPr>
          <a:xfrm flipH="1">
            <a:off x="6161999" y="6303356"/>
            <a:ext cx="8221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ontrol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3159D79-6914-F769-F058-FF9A967099B6}"/>
              </a:ext>
            </a:extLst>
          </p:cNvPr>
          <p:cNvSpPr txBox="1"/>
          <p:nvPr/>
        </p:nvSpPr>
        <p:spPr>
          <a:xfrm>
            <a:off x="7364858" y="2289425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E87DAB7-BE24-7369-2213-B041A5D285EB}"/>
              </a:ext>
            </a:extLst>
          </p:cNvPr>
          <p:cNvSpPr txBox="1"/>
          <p:nvPr/>
        </p:nvSpPr>
        <p:spPr>
          <a:xfrm>
            <a:off x="7436777" y="5628526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Helvetica" pitchFamily="2" charset="0"/>
              </a:rPr>
              <a:t>*</a:t>
            </a:r>
          </a:p>
        </p:txBody>
      </p:sp>
      <p:graphicFrame>
        <p:nvGraphicFramePr>
          <p:cNvPr id="81" name="Chart 80">
            <a:extLst>
              <a:ext uri="{FF2B5EF4-FFF2-40B4-BE49-F238E27FC236}">
                <a16:creationId xmlns:a16="http://schemas.microsoft.com/office/drawing/2014/main" id="{499F20CD-5D48-B062-B80D-F50D120CDA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9046635"/>
              </p:ext>
            </p:extLst>
          </p:nvPr>
        </p:nvGraphicFramePr>
        <p:xfrm>
          <a:off x="9614221" y="2025321"/>
          <a:ext cx="2088044" cy="20843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82" name="TextBox 81">
            <a:extLst>
              <a:ext uri="{FF2B5EF4-FFF2-40B4-BE49-F238E27FC236}">
                <a16:creationId xmlns:a16="http://schemas.microsoft.com/office/drawing/2014/main" id="{FAB6D635-1983-362B-150C-24EFF2114A4E}"/>
              </a:ext>
            </a:extLst>
          </p:cNvPr>
          <p:cNvSpPr txBox="1"/>
          <p:nvPr/>
        </p:nvSpPr>
        <p:spPr>
          <a:xfrm>
            <a:off x="9931445" y="1752650"/>
            <a:ext cx="1842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Fold enrichment (qPCR)</a:t>
            </a:r>
          </a:p>
        </p:txBody>
      </p:sp>
      <p:graphicFrame>
        <p:nvGraphicFramePr>
          <p:cNvPr id="83" name="Chart 82">
            <a:extLst>
              <a:ext uri="{FF2B5EF4-FFF2-40B4-BE49-F238E27FC236}">
                <a16:creationId xmlns:a16="http://schemas.microsoft.com/office/drawing/2014/main" id="{04B1DDCB-A0F5-18A5-8CF5-AF1AFD730B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96191226"/>
              </p:ext>
            </p:extLst>
          </p:nvPr>
        </p:nvGraphicFramePr>
        <p:xfrm>
          <a:off x="9694799" y="5389328"/>
          <a:ext cx="1935548" cy="16587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84" name="TextBox 83">
            <a:extLst>
              <a:ext uri="{FF2B5EF4-FFF2-40B4-BE49-F238E27FC236}">
                <a16:creationId xmlns:a16="http://schemas.microsoft.com/office/drawing/2014/main" id="{55355CF0-310D-55EA-8C7F-0510B112F1AB}"/>
              </a:ext>
            </a:extLst>
          </p:cNvPr>
          <p:cNvSpPr txBox="1"/>
          <p:nvPr/>
        </p:nvSpPr>
        <p:spPr>
          <a:xfrm>
            <a:off x="9868087" y="5192781"/>
            <a:ext cx="1842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Fold enrichment (qPCR)</a:t>
            </a:r>
          </a:p>
        </p:txBody>
      </p:sp>
      <p:grpSp>
        <p:nvGrpSpPr>
          <p:cNvPr id="73" name="Group 72">
            <a:extLst>
              <a:ext uri="{FF2B5EF4-FFF2-40B4-BE49-F238E27FC236}">
                <a16:creationId xmlns:a16="http://schemas.microsoft.com/office/drawing/2014/main" id="{66A50B17-66A7-31F2-E72A-7AEEDE404621}"/>
              </a:ext>
            </a:extLst>
          </p:cNvPr>
          <p:cNvGrpSpPr/>
          <p:nvPr/>
        </p:nvGrpSpPr>
        <p:grpSpPr>
          <a:xfrm>
            <a:off x="771332" y="4747863"/>
            <a:ext cx="4774827" cy="2476242"/>
            <a:chOff x="383400" y="4747863"/>
            <a:chExt cx="4774827" cy="2476242"/>
          </a:xfrm>
        </p:grpSpPr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8D9F6621-B3C3-C21F-B875-1F615C6F0B85}"/>
                </a:ext>
              </a:extLst>
            </p:cNvPr>
            <p:cNvSpPr txBox="1"/>
            <p:nvPr/>
          </p:nvSpPr>
          <p:spPr>
            <a:xfrm>
              <a:off x="398532" y="474786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Helvetica" pitchFamily="2" charset="0"/>
                  <a:cs typeface="Helvetica"/>
                </a:rPr>
                <a:t>B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BADB9E76-4E1E-1798-4172-D65A4EA49D8A}"/>
                </a:ext>
              </a:extLst>
            </p:cNvPr>
            <p:cNvSpPr txBox="1"/>
            <p:nvPr/>
          </p:nvSpPr>
          <p:spPr>
            <a:xfrm rot="18900000">
              <a:off x="4255048" y="5150253"/>
              <a:ext cx="61699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nput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73E9238B-06B4-A34F-1EF6-65733EC49173}"/>
                </a:ext>
              </a:extLst>
            </p:cNvPr>
            <p:cNvSpPr txBox="1"/>
            <p:nvPr/>
          </p:nvSpPr>
          <p:spPr>
            <a:xfrm rot="18900000">
              <a:off x="3928805" y="4935151"/>
              <a:ext cx="122942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No Ab control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9F571AEF-44B3-E1A0-E14B-F0AB75D8A0CB}"/>
                </a:ext>
              </a:extLst>
            </p:cNvPr>
            <p:cNvSpPr txBox="1"/>
            <p:nvPr/>
          </p:nvSpPr>
          <p:spPr>
            <a:xfrm rot="18900000">
              <a:off x="3700043" y="5002441"/>
              <a:ext cx="102473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IgG control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7B6C656E-CEA1-04DF-F6F2-58DAC26AAA80}"/>
                </a:ext>
              </a:extLst>
            </p:cNvPr>
            <p:cNvSpPr txBox="1"/>
            <p:nvPr/>
          </p:nvSpPr>
          <p:spPr>
            <a:xfrm rot="18900000">
              <a:off x="3417010" y="4992526"/>
              <a:ext cx="107341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hIP-</a:t>
              </a:r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itx2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E57DB097-32E2-F4B4-53DF-D4FCEA2F9F5A}"/>
                </a:ext>
              </a:extLst>
            </p:cNvPr>
            <p:cNvSpPr txBox="1"/>
            <p:nvPr/>
          </p:nvSpPr>
          <p:spPr>
            <a:xfrm rot="18900000">
              <a:off x="3141471" y="4968992"/>
              <a:ext cx="114200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hIP-Whsc1</a:t>
              </a:r>
              <a:endParaRPr 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14E106CC-6D95-C1A5-B4BC-DA8977D14F82}"/>
                </a:ext>
              </a:extLst>
            </p:cNvPr>
            <p:cNvSpPr txBox="1"/>
            <p:nvPr/>
          </p:nvSpPr>
          <p:spPr>
            <a:xfrm rot="18900000">
              <a:off x="2836491" y="4942925"/>
              <a:ext cx="119509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CR control</a:t>
              </a:r>
            </a:p>
          </p:txBody>
        </p:sp>
        <p:grpSp>
          <p:nvGrpSpPr>
            <p:cNvPr id="219" name="Group 218">
              <a:extLst>
                <a:ext uri="{FF2B5EF4-FFF2-40B4-BE49-F238E27FC236}">
                  <a16:creationId xmlns:a16="http://schemas.microsoft.com/office/drawing/2014/main" id="{FB88344F-DD97-9418-16CD-E1B5230400F7}"/>
                </a:ext>
              </a:extLst>
            </p:cNvPr>
            <p:cNvGrpSpPr/>
            <p:nvPr/>
          </p:nvGrpSpPr>
          <p:grpSpPr>
            <a:xfrm>
              <a:off x="2177070" y="5616157"/>
              <a:ext cx="833787" cy="276999"/>
              <a:chOff x="2021268" y="3277029"/>
              <a:chExt cx="469005" cy="155812"/>
            </a:xfrm>
          </p:grpSpPr>
          <p:sp>
            <p:nvSpPr>
              <p:cNvPr id="220" name="TextBox 219">
                <a:extLst>
                  <a:ext uri="{FF2B5EF4-FFF2-40B4-BE49-F238E27FC236}">
                    <a16:creationId xmlns:a16="http://schemas.microsoft.com/office/drawing/2014/main" id="{ADE2359E-B9AD-21A5-148F-9C0BEB6CE1CF}"/>
                  </a:ext>
                </a:extLst>
              </p:cNvPr>
              <p:cNvSpPr txBox="1"/>
              <p:nvPr/>
            </p:nvSpPr>
            <p:spPr>
              <a:xfrm>
                <a:off x="2021268" y="3277029"/>
                <a:ext cx="469005" cy="15581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00bp</a:t>
                </a:r>
              </a:p>
            </p:txBody>
          </p:sp>
          <p:cxnSp>
            <p:nvCxnSpPr>
              <p:cNvPr id="221" name="Straight Connector 220">
                <a:extLst>
                  <a:ext uri="{FF2B5EF4-FFF2-40B4-BE49-F238E27FC236}">
                    <a16:creationId xmlns:a16="http://schemas.microsoft.com/office/drawing/2014/main" id="{FBF1F0B3-47EC-A160-4E1A-FE68FC453E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38987" y="3366170"/>
                <a:ext cx="127616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22" name="Group 221">
              <a:extLst>
                <a:ext uri="{FF2B5EF4-FFF2-40B4-BE49-F238E27FC236}">
                  <a16:creationId xmlns:a16="http://schemas.microsoft.com/office/drawing/2014/main" id="{BA5E3E0B-A3E2-20D4-3C81-49BA9211276D}"/>
                </a:ext>
              </a:extLst>
            </p:cNvPr>
            <p:cNvGrpSpPr/>
            <p:nvPr/>
          </p:nvGrpSpPr>
          <p:grpSpPr>
            <a:xfrm>
              <a:off x="2166515" y="5854364"/>
              <a:ext cx="833787" cy="276999"/>
              <a:chOff x="2015489" y="3288587"/>
              <a:chExt cx="469005" cy="155812"/>
            </a:xfrm>
          </p:grpSpPr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D3FC2F2C-98FC-771D-614F-BC4469DB0CA7}"/>
                  </a:ext>
                </a:extLst>
              </p:cNvPr>
              <p:cNvSpPr txBox="1"/>
              <p:nvPr/>
            </p:nvSpPr>
            <p:spPr>
              <a:xfrm>
                <a:off x="2015489" y="3288587"/>
                <a:ext cx="469005" cy="15581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00bp</a:t>
                </a:r>
              </a:p>
            </p:txBody>
          </p:sp>
          <p:cxnSp>
            <p:nvCxnSpPr>
              <p:cNvPr id="224" name="Straight Connector 223">
                <a:extLst>
                  <a:ext uri="{FF2B5EF4-FFF2-40B4-BE49-F238E27FC236}">
                    <a16:creationId xmlns:a16="http://schemas.microsoft.com/office/drawing/2014/main" id="{80560E8D-EABE-A2E7-9797-24070391A3E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38987" y="3366170"/>
                <a:ext cx="127616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2B373355-EE96-4A6B-2D18-9FF1D27B6357}"/>
                </a:ext>
              </a:extLst>
            </p:cNvPr>
            <p:cNvSpPr txBox="1"/>
            <p:nvPr/>
          </p:nvSpPr>
          <p:spPr>
            <a:xfrm flipH="1">
              <a:off x="1571946" y="5098085"/>
              <a:ext cx="1325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Sox2 </a:t>
              </a:r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promot</a:t>
              </a:r>
              <a:r>
                <a:rPr lang="en-US" altLang="zh-CN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e</a:t>
              </a:r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r</a:t>
              </a:r>
            </a:p>
          </p:txBody>
        </p:sp>
        <p:grpSp>
          <p:nvGrpSpPr>
            <p:cNvPr id="229" name="Group 228">
              <a:extLst>
                <a:ext uri="{FF2B5EF4-FFF2-40B4-BE49-F238E27FC236}">
                  <a16:creationId xmlns:a16="http://schemas.microsoft.com/office/drawing/2014/main" id="{DB7367EE-DB5B-217D-E4DC-FD701EEACAD4}"/>
                </a:ext>
              </a:extLst>
            </p:cNvPr>
            <p:cNvGrpSpPr/>
            <p:nvPr/>
          </p:nvGrpSpPr>
          <p:grpSpPr>
            <a:xfrm>
              <a:off x="2158550" y="6540439"/>
              <a:ext cx="833787" cy="276999"/>
              <a:chOff x="2009710" y="3282808"/>
              <a:chExt cx="469005" cy="155812"/>
            </a:xfrm>
          </p:grpSpPr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B159D82B-00D2-4017-934B-217D8FD1EF7F}"/>
                  </a:ext>
                </a:extLst>
              </p:cNvPr>
              <p:cNvSpPr txBox="1"/>
              <p:nvPr/>
            </p:nvSpPr>
            <p:spPr>
              <a:xfrm>
                <a:off x="2009710" y="3282808"/>
                <a:ext cx="469005" cy="15581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00bp</a:t>
                </a:r>
              </a:p>
            </p:txBody>
          </p:sp>
          <p:cxnSp>
            <p:nvCxnSpPr>
              <p:cNvPr id="231" name="Straight Connector 230">
                <a:extLst>
                  <a:ext uri="{FF2B5EF4-FFF2-40B4-BE49-F238E27FC236}">
                    <a16:creationId xmlns:a16="http://schemas.microsoft.com/office/drawing/2014/main" id="{845BE596-C7A8-2292-C189-D1B6FD55FC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38987" y="3366170"/>
                <a:ext cx="127616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AE0CFA18-7B5C-695A-17A2-7C83262C2711}"/>
                </a:ext>
              </a:extLst>
            </p:cNvPr>
            <p:cNvSpPr txBox="1"/>
            <p:nvPr/>
          </p:nvSpPr>
          <p:spPr>
            <a:xfrm>
              <a:off x="2158268" y="6756036"/>
              <a:ext cx="65373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100bp</a:t>
              </a:r>
            </a:p>
          </p:txBody>
        </p:sp>
        <p:cxnSp>
          <p:nvCxnSpPr>
            <p:cNvPr id="234" name="Straight Connector 233">
              <a:extLst>
                <a:ext uri="{FF2B5EF4-FFF2-40B4-BE49-F238E27FC236}">
                  <a16:creationId xmlns:a16="http://schemas.microsoft.com/office/drawing/2014/main" id="{C4090A25-8E63-B5E9-927A-45483B9E56AC}"/>
                </a:ext>
              </a:extLst>
            </p:cNvPr>
            <p:cNvCxnSpPr>
              <a:cxnSpLocks/>
            </p:cNvCxnSpPr>
            <p:nvPr/>
          </p:nvCxnSpPr>
          <p:spPr>
            <a:xfrm>
              <a:off x="2743650" y="6914508"/>
              <a:ext cx="226873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F647CB83-26DE-E8B8-E0B0-EC7DA766F484}"/>
                </a:ext>
              </a:extLst>
            </p:cNvPr>
            <p:cNvSpPr txBox="1"/>
            <p:nvPr/>
          </p:nvSpPr>
          <p:spPr>
            <a:xfrm flipH="1">
              <a:off x="1808252" y="6199705"/>
              <a:ext cx="8002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ontrol</a:t>
              </a:r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68B6E67F-0357-F2A6-EED9-97EED3F7D73E}"/>
                </a:ext>
              </a:extLst>
            </p:cNvPr>
            <p:cNvGrpSpPr/>
            <p:nvPr/>
          </p:nvGrpSpPr>
          <p:grpSpPr>
            <a:xfrm>
              <a:off x="383400" y="5592075"/>
              <a:ext cx="1430751" cy="944893"/>
              <a:chOff x="1433536" y="5962010"/>
              <a:chExt cx="1171631" cy="773765"/>
            </a:xfrm>
          </p:grpSpPr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6F31A501-B6E0-5AD5-2886-D42172C117EE}"/>
                  </a:ext>
                </a:extLst>
              </p:cNvPr>
              <p:cNvSpPr txBox="1"/>
              <p:nvPr/>
            </p:nvSpPr>
            <p:spPr>
              <a:xfrm>
                <a:off x="1621350" y="5962010"/>
                <a:ext cx="416994" cy="226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>
                        <a:lumMod val="50000"/>
                      </a:schemeClr>
                    </a:solidFill>
                    <a:latin typeface="Helvetica" pitchFamily="2" charset="0"/>
                    <a:cs typeface="Helvetica" panose="020B0604020202020204" pitchFamily="34" charset="0"/>
                  </a:rPr>
                  <a:t>con</a:t>
                </a:r>
              </a:p>
            </p:txBody>
          </p: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1E3D87B8-16B0-8A17-1FB6-6ABFB69088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6235" y="6153488"/>
                <a:ext cx="0" cy="370657"/>
              </a:xfrm>
              <a:prstGeom prst="line">
                <a:avLst/>
              </a:prstGeom>
              <a:ln w="12700"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1777F06C-1446-7AD0-3865-C07B58B6DBA2}"/>
                  </a:ext>
                </a:extLst>
              </p:cNvPr>
              <p:cNvSpPr/>
              <p:nvPr/>
            </p:nvSpPr>
            <p:spPr>
              <a:xfrm>
                <a:off x="1784066" y="6203503"/>
                <a:ext cx="73023" cy="12917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>
                  <a:latin typeface="Helvetica" pitchFamily="2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AD288A0A-3D57-C71F-0F80-0786B5D590AB}"/>
                  </a:ext>
                </a:extLst>
              </p:cNvPr>
              <p:cNvSpPr txBox="1"/>
              <p:nvPr/>
            </p:nvSpPr>
            <p:spPr>
              <a:xfrm>
                <a:off x="1447696" y="6508943"/>
                <a:ext cx="729389" cy="226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200" b="1" i="1" dirty="0">
                    <a:latin typeface="Helvetica" pitchFamily="2" charset="0"/>
                    <a:cs typeface="Helvetica" panose="020B0604020202020204" pitchFamily="34" charset="0"/>
                  </a:rPr>
                  <a:t> Sox2</a:t>
                </a:r>
                <a:r>
                  <a:rPr lang="en-US" sz="1200" b="1" dirty="0">
                    <a:latin typeface="Helvetica" pitchFamily="2" charset="0"/>
                    <a:cs typeface="Helvetica" panose="020B0604020202020204" pitchFamily="34" charset="0"/>
                  </a:rPr>
                  <a:t> pro</a:t>
                </a: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35B72B16-C822-3641-54F5-AC6D3129DB54}"/>
                  </a:ext>
                </a:extLst>
              </p:cNvPr>
              <p:cNvSpPr/>
              <p:nvPr/>
            </p:nvSpPr>
            <p:spPr>
              <a:xfrm>
                <a:off x="2131938" y="6425654"/>
                <a:ext cx="389374" cy="20966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b="1" dirty="0">
                  <a:latin typeface="Helvetica" pitchFamily="2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F2395BA-2D74-3E68-798F-AA57F1440228}"/>
                  </a:ext>
                </a:extLst>
              </p:cNvPr>
              <p:cNvSpPr txBox="1"/>
              <p:nvPr/>
            </p:nvSpPr>
            <p:spPr>
              <a:xfrm>
                <a:off x="2040449" y="6205055"/>
                <a:ext cx="564718" cy="226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Helvetica" pitchFamily="2" charset="0"/>
                    <a:cs typeface="Helvetica" panose="020B0604020202020204" pitchFamily="34" charset="0"/>
                  </a:rPr>
                  <a:t>Exon 1</a:t>
                </a:r>
              </a:p>
            </p:txBody>
          </p:sp>
          <p:cxnSp>
            <p:nvCxnSpPr>
              <p:cNvPr id="25" name="Straight Connector 24">
                <a:extLst>
                  <a:ext uri="{FF2B5EF4-FFF2-40B4-BE49-F238E27FC236}">
                    <a16:creationId xmlns:a16="http://schemas.microsoft.com/office/drawing/2014/main" id="{BD94C2AC-198F-A666-2A3C-7125755A29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83298" y="6532266"/>
                <a:ext cx="54864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3FC2374-A7BF-3BDF-8748-68A0847747FE}"/>
                  </a:ext>
                </a:extLst>
              </p:cNvPr>
              <p:cNvSpPr txBox="1"/>
              <p:nvPr/>
            </p:nvSpPr>
            <p:spPr>
              <a:xfrm>
                <a:off x="1433536" y="6134042"/>
                <a:ext cx="681149" cy="226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Helvetica" pitchFamily="2" charset="0"/>
                    <a:cs typeface="Helvetica" panose="020B0604020202020204" pitchFamily="34" charset="0"/>
                  </a:rPr>
                  <a:t>-866</a:t>
                </a:r>
                <a:r>
                  <a:rPr lang="zh-CN" altLang="en-US" sz="1200" b="1" dirty="0">
                    <a:latin typeface="Helvetica" pitchFamily="2" charset="0"/>
                    <a:cs typeface="Helvetica" panose="020B0604020202020204" pitchFamily="34" charset="0"/>
                  </a:rPr>
                  <a:t> </a:t>
                </a:r>
                <a:r>
                  <a:rPr lang="en-US" sz="1200" b="1" dirty="0">
                    <a:latin typeface="Helvetica" pitchFamily="2" charset="0"/>
                    <a:cs typeface="Helvetica" panose="020B0604020202020204" pitchFamily="34" charset="0"/>
                  </a:rPr>
                  <a:t>bp</a:t>
                </a:r>
              </a:p>
            </p:txBody>
          </p: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97688E13-0340-82E0-F7FE-34D672E803DE}"/>
                  </a:ext>
                </a:extLst>
              </p:cNvPr>
              <p:cNvGrpSpPr/>
              <p:nvPr/>
            </p:nvGrpSpPr>
            <p:grpSpPr>
              <a:xfrm>
                <a:off x="1777763" y="6241566"/>
                <a:ext cx="349647" cy="281554"/>
                <a:chOff x="5063053" y="4212150"/>
                <a:chExt cx="349647" cy="281554"/>
              </a:xfrm>
            </p:grpSpPr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EE5F78AE-1E2E-F5D9-CDB1-92B0B911FF59}"/>
                    </a:ext>
                  </a:extLst>
                </p:cNvPr>
                <p:cNvCxnSpPr/>
                <p:nvPr/>
              </p:nvCxnSpPr>
              <p:spPr>
                <a:xfrm>
                  <a:off x="5168623" y="4394164"/>
                  <a:ext cx="0" cy="995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B7DBDB8C-2901-CFA6-2F10-44727DE94A22}"/>
                    </a:ext>
                  </a:extLst>
                </p:cNvPr>
                <p:cNvSpPr txBox="1"/>
                <p:nvPr/>
              </p:nvSpPr>
              <p:spPr>
                <a:xfrm>
                  <a:off x="5063053" y="4212150"/>
                  <a:ext cx="349647" cy="226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en-US" sz="1200" b="1" dirty="0">
                      <a:solidFill>
                        <a:srgbClr val="000000"/>
                      </a:solidFill>
                      <a:latin typeface="Helvetica" pitchFamily="2" charset="0"/>
                    </a:rPr>
                    <a:t>#</a:t>
                  </a:r>
                  <a:endParaRPr lang="en-US" sz="1200" b="1" dirty="0">
                    <a:latin typeface="Helvetica" pitchFamily="2" charset="0"/>
                  </a:endParaRPr>
                </a:p>
              </p:txBody>
            </p:sp>
          </p:grp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96533A8-9D21-B2B4-5DAD-F07508564BE3}"/>
                </a:ext>
              </a:extLst>
            </p:cNvPr>
            <p:cNvSpPr txBox="1"/>
            <p:nvPr/>
          </p:nvSpPr>
          <p:spPr>
            <a:xfrm>
              <a:off x="3234647" y="5741541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  <a:latin typeface="Helvetica" pitchFamily="2" charset="0"/>
                </a:rPr>
                <a:t>*</a:t>
              </a:r>
            </a:p>
          </p:txBody>
        </p:sp>
        <p:pic>
          <p:nvPicPr>
            <p:cNvPr id="33" name="Picture 32" descr="A blurry image of a light&#10;&#10;Description automatically generated">
              <a:extLst>
                <a:ext uri="{FF2B5EF4-FFF2-40B4-BE49-F238E27FC236}">
                  <a16:creationId xmlns:a16="http://schemas.microsoft.com/office/drawing/2014/main" id="{3604CAC4-B073-ACE8-FAD5-9DBE6700D5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298" t="5304" r="13888" b="55105"/>
            <a:stretch/>
          </p:blipFill>
          <p:spPr>
            <a:xfrm rot="5400000">
              <a:off x="3337901" y="5163287"/>
              <a:ext cx="889346" cy="1551142"/>
            </a:xfrm>
            <a:prstGeom prst="rect">
              <a:avLst/>
            </a:prstGeom>
          </p:spPr>
        </p:pic>
        <p:pic>
          <p:nvPicPr>
            <p:cNvPr id="56" name="Picture 55" descr="A blurry image of a light&#10;&#10;Description automatically generated">
              <a:extLst>
                <a:ext uri="{FF2B5EF4-FFF2-40B4-BE49-F238E27FC236}">
                  <a16:creationId xmlns:a16="http://schemas.microsoft.com/office/drawing/2014/main" id="{76A14EA8-9236-0A36-53E2-20ADE75AD0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138" t="52192" r="16827" b="7481"/>
            <a:stretch/>
          </p:blipFill>
          <p:spPr>
            <a:xfrm rot="5400000">
              <a:off x="3400432" y="6052538"/>
              <a:ext cx="776617" cy="156651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03700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8B87BA2AB25E442BD3E26FFCCB4725E" ma:contentTypeVersion="14" ma:contentTypeDescription="Create a new document." ma:contentTypeScope="" ma:versionID="49af1c8a26ae5946cd5b396a27bb08e8">
  <xsd:schema xmlns:xsd="http://www.w3.org/2001/XMLSchema" xmlns:xs="http://www.w3.org/2001/XMLSchema" xmlns:p="http://schemas.microsoft.com/office/2006/metadata/properties" xmlns:ns3="1fe4a7e6-0781-4223-92a9-cff86e5a1a8b" xmlns:ns4="379de845-6c3c-40ac-b46f-2ff42365e8a1" targetNamespace="http://schemas.microsoft.com/office/2006/metadata/properties" ma:root="true" ma:fieldsID="e94493a0dda3e71182790e9de226d6ff" ns3:_="" ns4:_="">
    <xsd:import namespace="1fe4a7e6-0781-4223-92a9-cff86e5a1a8b"/>
    <xsd:import namespace="379de845-6c3c-40ac-b46f-2ff42365e8a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e4a7e6-0781-4223-92a9-cff86e5a1a8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9de845-6c3c-40ac-b46f-2ff42365e8a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8C9FE77A-C817-4A7E-BC3E-F7DADD89B1D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B082C0F-5B64-4AF4-80A5-545CDB20AC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e4a7e6-0781-4223-92a9-cff86e5a1a8b"/>
    <ds:schemaRef ds:uri="379de845-6c3c-40ac-b46f-2ff42365e8a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6E242034-1141-4B10-9E97-BBA0B09643D9}">
  <ds:schemaRefs>
    <ds:schemaRef ds:uri="1fe4a7e6-0781-4223-92a9-cff86e5a1a8b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379de845-6c3c-40ac-b46f-2ff42365e8a1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57</TotalTime>
  <Words>448</Words>
  <Application>Microsoft Macintosh PowerPoint</Application>
  <PresentationFormat>Custom</PresentationFormat>
  <Paragraphs>7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NewRomanPSM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, Dan</dc:creator>
  <cp:lastModifiedBy>Microsoft Office User</cp:lastModifiedBy>
  <cp:revision>12</cp:revision>
  <cp:lastPrinted>2023-04-11T22:57:55Z</cp:lastPrinted>
  <dcterms:created xsi:type="dcterms:W3CDTF">2022-10-11T15:48:40Z</dcterms:created>
  <dcterms:modified xsi:type="dcterms:W3CDTF">2023-10-03T20:12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8B87BA2AB25E442BD3E26FFCCB4725E</vt:lpwstr>
  </property>
</Properties>
</file>